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F560C-21CD-40A0-A965-835139AB0B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641FE-360F-49AA-A1BC-52B2441780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966F3-D703-42C5-B947-6190164093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69E94-BCC8-4509-8952-765781C41C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00817-1592-40F1-AD65-4E60E9E7BA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581E0-9F68-48B7-A696-E49D3F049A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90151-4CF1-40FD-B658-FAF0A50E14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117B3-B5C5-4BB0-A80F-122B6CD02D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97ED1-E8E3-4515-8D9B-521C7E1C4D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EF147-BB76-45F3-BD6F-AC6B1DA7C4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14C48-15ED-4957-A187-057468053A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FBDCE-2D0B-4F81-B638-812EB38150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D83C28-45DC-45C9-86A7-2F75CCCFB2E2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51200" y="1341360"/>
          <a:ext cx="5329080" cy="4540320"/>
        </p:xfrm>
        <a:graphic>
          <a:graphicData uri="http://schemas.openxmlformats.org/drawingml/2006/table">
            <a:tbl>
              <a:tblPr/>
              <a:tblGrid>
                <a:gridCol w="2952720"/>
                <a:gridCol w="649080"/>
                <a:gridCol w="790560"/>
                <a:gridCol w="936720"/>
              </a:tblGrid>
              <a:tr h="28728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ymb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Fol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(TR/RIF-1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cession 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27, heat shock protein 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p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19.7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3560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family with sequence similarity 198, member 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198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12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33187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ysteine rich protein 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i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7.9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422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0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gene regulated by estrogen in breast cancer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e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6.2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5764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stallin, alpha B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ya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3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9964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omponent of Sp100-rs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p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33616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guanylate nucleotide binding protein 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bp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873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phosphatidylinositol transfer protein, cytoplasmic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tpnc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4582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ldehyde dehydrogenase family 3, subfamily 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dh3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7436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interferon gamma induced GTPase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t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8738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bone marrow stromal cell antigen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s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4.9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98095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immunity-related GTPase family M member 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I481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4.8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9440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interferon-induced protein with tetratricopeptide repeats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fit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6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050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rmadillo repeat containing, X-linked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mcx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6139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ISG15 ubiquitin-like modifi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578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AR-related orphan receptor be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r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5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46095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yncoil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n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3485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interferon-induced protein with tetratricopeptide repeats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fit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050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purinergic receptor P2Y, G-protein coupled, 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ry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33200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ldehyde oxidase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ox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9676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adical S-adenosyl methionine domain containing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sad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138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eceptor (calcitonin) activity modifying protei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m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6894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polipoprotein L 9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pol9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73743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GTP cyclohydrolase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h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8102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uclear protei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l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39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1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meiosis-specific nuclear structural protei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p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973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ypothetical protein LOC22367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ns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861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" name="Text Box 1220"/>
          <p:cNvSpPr/>
          <p:nvPr/>
        </p:nvSpPr>
        <p:spPr>
          <a:xfrm>
            <a:off x="104040" y="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1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 Box 2081"/>
          <p:cNvSpPr/>
          <p:nvPr/>
        </p:nvSpPr>
        <p:spPr>
          <a:xfrm>
            <a:off x="1866960" y="907920"/>
            <a:ext cx="634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1. Genes up-regulated more than 3-fold in TR cells compared to RIF-1 cells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3T02:49:26Z</dcterms:created>
  <dc:creator>김희정</dc:creator>
  <dc:description/>
  <dc:language>en-US</dc:language>
  <cp:lastModifiedBy>김희정</cp:lastModifiedBy>
  <dcterms:modified xsi:type="dcterms:W3CDTF">2011-06-14T01:50:12Z</dcterms:modified>
  <cp:revision>201</cp:revision>
  <dc:subject/>
  <dc:title>슬라이드 1</dc:title>
</cp:coreProperties>
</file>